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fr-FR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 showGuides="1">
      <p:cViewPr>
        <p:scale>
          <a:sx n="100" d="100"/>
          <a:sy n="100" d="100"/>
        </p:scale>
        <p:origin x="-1656" y="-80"/>
      </p:cViewPr>
      <p:guideLst>
        <p:guide orient="horz" pos="5759"/>
        <p:guide pos="4319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fr-FR" smtClean="0"/>
              <a:t>Cliquez et modifiez le titre</a:t>
            </a:r>
            <a:endParaRPr lang="en-US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Cliquez pour modifier le style des sous-titres du masque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160C0C-0B3F-5842-AE2C-DB8AF7F4C16B}" type="datetimeFigureOut">
              <a:rPr lang="fr-FR" smtClean="0"/>
              <a:t>13/09/2018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755DFD-0E1A-F34F-8E70-D434EBDB6E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0556533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en-US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160C0C-0B3F-5842-AE2C-DB8AF7F4C16B}" type="datetimeFigureOut">
              <a:rPr lang="fr-FR" smtClean="0"/>
              <a:t>13/09/2018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755DFD-0E1A-F34F-8E70-D434EBDB6E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748347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fr-FR" smtClean="0"/>
              <a:t>Cliquez et modifiez le titre</a:t>
            </a:r>
            <a:endParaRPr lang="en-US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160C0C-0B3F-5842-AE2C-DB8AF7F4C16B}" type="datetimeFigureOut">
              <a:rPr lang="fr-FR" smtClean="0"/>
              <a:t>13/09/2018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755DFD-0E1A-F34F-8E70-D434EBDB6E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1082637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en-US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160C0C-0B3F-5842-AE2C-DB8AF7F4C16B}" type="datetimeFigureOut">
              <a:rPr lang="fr-FR" smtClean="0"/>
              <a:t>13/09/2018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755DFD-0E1A-F34F-8E70-D434EBDB6E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8648823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-têt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Cliquez et modifiez le titre</a:t>
            </a:r>
            <a:endParaRPr lang="en-US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160C0C-0B3F-5842-AE2C-DB8AF7F4C16B}" type="datetimeFigureOut">
              <a:rPr lang="fr-FR" smtClean="0"/>
              <a:t>13/09/2018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755DFD-0E1A-F34F-8E70-D434EBDB6E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4455693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en-US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160C0C-0B3F-5842-AE2C-DB8AF7F4C16B}" type="datetimeFigureOut">
              <a:rPr lang="fr-FR" smtClean="0"/>
              <a:t>13/09/2018</a:t>
            </a:fld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755DFD-0E1A-F34F-8E70-D434EBDB6E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6070237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 smtClean="0"/>
              <a:t>Cliquez et modifiez le titre</a:t>
            </a:r>
            <a:endParaRPr lang="en-US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160C0C-0B3F-5842-AE2C-DB8AF7F4C16B}" type="datetimeFigureOut">
              <a:rPr lang="fr-FR" smtClean="0"/>
              <a:t>13/09/2018</a:t>
            </a:fld>
            <a:endParaRPr lang="en-US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755DFD-0E1A-F34F-8E70-D434EBDB6E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5997998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en-US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160C0C-0B3F-5842-AE2C-DB8AF7F4C16B}" type="datetimeFigureOut">
              <a:rPr lang="fr-FR" smtClean="0"/>
              <a:t>13/09/2018</a:t>
            </a:fld>
            <a:endParaRPr lang="en-US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755DFD-0E1A-F34F-8E70-D434EBDB6E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5719330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160C0C-0B3F-5842-AE2C-DB8AF7F4C16B}" type="datetimeFigureOut">
              <a:rPr lang="fr-FR" smtClean="0"/>
              <a:t>13/09/2018</a:t>
            </a:fld>
            <a:endParaRPr lang="en-US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755DFD-0E1A-F34F-8E70-D434EBDB6E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4949518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et modifiez le titre</a:t>
            </a:r>
            <a:endParaRPr lang="en-US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160C0C-0B3F-5842-AE2C-DB8AF7F4C16B}" type="datetimeFigureOut">
              <a:rPr lang="fr-FR" smtClean="0"/>
              <a:t>13/09/2018</a:t>
            </a:fld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755DFD-0E1A-F34F-8E70-D434EBDB6E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5489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et modifiez le titre</a:t>
            </a:r>
            <a:endParaRPr lang="en-US"/>
          </a:p>
        </p:txBody>
      </p:sp>
      <p:sp>
        <p:nvSpPr>
          <p:cNvPr id="3" name="Espace réservé pour une image 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fr-FR" smtClean="0"/>
              <a:t>Faire glisser l'image vers l'espace réservé ou cliquer sur l'icône pour l'ajouter</a:t>
            </a:r>
            <a:endParaRPr lang="en-US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160C0C-0B3F-5842-AE2C-DB8AF7F4C16B}" type="datetimeFigureOut">
              <a:rPr lang="fr-FR" smtClean="0"/>
              <a:t>13/09/2018</a:t>
            </a:fld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755DFD-0E1A-F34F-8E70-D434EBDB6E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0795160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Cliquez et modifiez le titre</a:t>
            </a:r>
            <a:endParaRPr lang="en-US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F160C0C-0B3F-5842-AE2C-DB8AF7F4C16B}" type="datetimeFigureOut">
              <a:rPr lang="fr-FR" smtClean="0"/>
              <a:t>13/09/2018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4755DFD-0E1A-F34F-8E70-D434EBDB6E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5412444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4" Type="http://schemas.openxmlformats.org/officeDocument/2006/relationships/image" Target="../media/image3.png"/><Relationship Id="rId5" Type="http://schemas.openxmlformats.org/officeDocument/2006/relationships/image" Target="../media/image4.png"/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age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771170" y="1230853"/>
            <a:ext cx="1361238" cy="1120531"/>
          </a:xfrm>
          <a:prstGeom prst="rect">
            <a:avLst/>
          </a:prstGeom>
        </p:spPr>
      </p:pic>
      <p:sp>
        <p:nvSpPr>
          <p:cNvPr id="13" name="ZoneTexte 12"/>
          <p:cNvSpPr txBox="1"/>
          <p:nvPr/>
        </p:nvSpPr>
        <p:spPr>
          <a:xfrm>
            <a:off x="619666" y="527243"/>
            <a:ext cx="105269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smtClean="0"/>
              <a:t>Figure </a:t>
            </a:r>
            <a:r>
              <a:rPr lang="en-US" sz="1600" smtClean="0"/>
              <a:t>S12</a:t>
            </a:r>
            <a:endParaRPr lang="en-US" sz="1600" dirty="0" smtClean="0"/>
          </a:p>
        </p:txBody>
      </p:sp>
      <p:grpSp>
        <p:nvGrpSpPr>
          <p:cNvPr id="18" name="Grouper 17"/>
          <p:cNvGrpSpPr/>
          <p:nvPr/>
        </p:nvGrpSpPr>
        <p:grpSpPr>
          <a:xfrm>
            <a:off x="1608858" y="3019425"/>
            <a:ext cx="2880378" cy="1166962"/>
            <a:chOff x="1608858" y="3019425"/>
            <a:chExt cx="2880378" cy="1166962"/>
          </a:xfrm>
        </p:grpSpPr>
        <p:pic>
          <p:nvPicPr>
            <p:cNvPr id="6" name="Image 5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1734801" y="3019425"/>
              <a:ext cx="648226" cy="663576"/>
            </a:xfrm>
            <a:prstGeom prst="rect">
              <a:avLst/>
            </a:prstGeom>
          </p:spPr>
        </p:pic>
        <p:pic>
          <p:nvPicPr>
            <p:cNvPr id="7" name="Image 6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2707928" y="3019425"/>
              <a:ext cx="648226" cy="663576"/>
            </a:xfrm>
            <a:prstGeom prst="rect">
              <a:avLst/>
            </a:prstGeom>
          </p:spPr>
        </p:pic>
        <p:pic>
          <p:nvPicPr>
            <p:cNvPr id="8" name="Image 7"/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3706284" y="3019425"/>
              <a:ext cx="648226" cy="663576"/>
            </a:xfrm>
            <a:prstGeom prst="rect">
              <a:avLst/>
            </a:prstGeom>
          </p:spPr>
        </p:pic>
        <p:sp>
          <p:nvSpPr>
            <p:cNvPr id="12" name="ZoneTexte 11"/>
            <p:cNvSpPr txBox="1"/>
            <p:nvPr/>
          </p:nvSpPr>
          <p:spPr>
            <a:xfrm>
              <a:off x="1608858" y="3755500"/>
              <a:ext cx="900112" cy="43088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100" dirty="0" smtClean="0"/>
                <a:t>pAS2-CDC13</a:t>
              </a:r>
            </a:p>
            <a:p>
              <a:pPr algn="ctr"/>
              <a:r>
                <a:rPr lang="en-US" sz="1100" dirty="0" smtClean="0"/>
                <a:t>pACT2-STN1</a:t>
              </a:r>
              <a:endParaRPr lang="en-US" sz="1100" dirty="0"/>
            </a:p>
          </p:txBody>
        </p:sp>
        <p:sp>
          <p:nvSpPr>
            <p:cNvPr id="16" name="ZoneTexte 15"/>
            <p:cNvSpPr txBox="1"/>
            <p:nvPr/>
          </p:nvSpPr>
          <p:spPr>
            <a:xfrm>
              <a:off x="2419396" y="3755500"/>
              <a:ext cx="1225290" cy="43088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100" dirty="0" smtClean="0"/>
                <a:t>pAS2-CDC13</a:t>
              </a:r>
            </a:p>
            <a:p>
              <a:pPr algn="ctr"/>
              <a:r>
                <a:rPr lang="en-US" sz="1100" dirty="0" smtClean="0"/>
                <a:t>pACT2-POL1-1146</a:t>
              </a:r>
              <a:endParaRPr lang="en-US" sz="1100" dirty="0"/>
            </a:p>
          </p:txBody>
        </p:sp>
        <p:sp>
          <p:nvSpPr>
            <p:cNvPr id="17" name="ZoneTexte 16"/>
            <p:cNvSpPr txBox="1"/>
            <p:nvPr/>
          </p:nvSpPr>
          <p:spPr>
            <a:xfrm>
              <a:off x="3571559" y="3755500"/>
              <a:ext cx="917677" cy="43088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 smtClean="0"/>
                <a:t>pAS2-CDC13</a:t>
              </a:r>
            </a:p>
            <a:p>
              <a:r>
                <a:rPr lang="en-US" sz="1100" dirty="0" smtClean="0"/>
                <a:t>pACT2-alone</a:t>
              </a:r>
              <a:endParaRPr lang="en-US" sz="1100" dirty="0"/>
            </a:p>
          </p:txBody>
        </p:sp>
      </p:grpSp>
      <p:sp>
        <p:nvSpPr>
          <p:cNvPr id="19" name="ZoneTexte 18"/>
          <p:cNvSpPr txBox="1"/>
          <p:nvPr/>
        </p:nvSpPr>
        <p:spPr>
          <a:xfrm>
            <a:off x="3071612" y="1259164"/>
            <a:ext cx="1146148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 smtClean="0"/>
              <a:t>pAS2-POL1-1146</a:t>
            </a:r>
          </a:p>
          <a:p>
            <a:r>
              <a:rPr lang="en-US" sz="1100" dirty="0" smtClean="0"/>
              <a:t>pACT2-SPT5-630</a:t>
            </a:r>
            <a:endParaRPr lang="en-US" sz="1100" dirty="0"/>
          </a:p>
        </p:txBody>
      </p:sp>
      <p:sp>
        <p:nvSpPr>
          <p:cNvPr id="20" name="ZoneTexte 19"/>
          <p:cNvSpPr txBox="1"/>
          <p:nvPr/>
        </p:nvSpPr>
        <p:spPr>
          <a:xfrm>
            <a:off x="3071612" y="1863004"/>
            <a:ext cx="1146148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 smtClean="0"/>
              <a:t>pAS2-POL1-1146</a:t>
            </a:r>
          </a:p>
          <a:p>
            <a:r>
              <a:rPr lang="en-US" sz="1100" dirty="0" smtClean="0"/>
              <a:t>pACT2-alone</a:t>
            </a:r>
            <a:endParaRPr lang="en-US" sz="1100" dirty="0"/>
          </a:p>
        </p:txBody>
      </p:sp>
      <p:sp>
        <p:nvSpPr>
          <p:cNvPr id="21" name="ZoneTexte 20"/>
          <p:cNvSpPr txBox="1"/>
          <p:nvPr/>
        </p:nvSpPr>
        <p:spPr>
          <a:xfrm>
            <a:off x="1380799" y="936598"/>
            <a:ext cx="30338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smtClean="0"/>
              <a:t>A</a:t>
            </a:r>
          </a:p>
        </p:txBody>
      </p:sp>
      <p:sp>
        <p:nvSpPr>
          <p:cNvPr id="22" name="ZoneTexte 21"/>
          <p:cNvSpPr txBox="1"/>
          <p:nvPr/>
        </p:nvSpPr>
        <p:spPr>
          <a:xfrm>
            <a:off x="1381505" y="2680871"/>
            <a:ext cx="30338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smtClean="0"/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3286936430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par défaut">
  <a:themeElements>
    <a:clrScheme name="Bureau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Bureau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Bureau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>Thème par défaut.thmx</Template>
  <TotalTime>36</TotalTime>
  <Words>42</Words>
  <Application>Microsoft Macintosh PowerPoint</Application>
  <PresentationFormat>Présentation à l'écran (4:3)</PresentationFormat>
  <Paragraphs>13</Paragraphs>
  <Slides>1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par défaut</vt:lpstr>
      <vt:lpstr>Présentation PowerPoint</vt:lpstr>
    </vt:vector>
  </TitlesOfParts>
  <Company>GICC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Nathalie Grandin</dc:creator>
  <cp:lastModifiedBy>Gicc</cp:lastModifiedBy>
  <cp:revision>8</cp:revision>
  <dcterms:created xsi:type="dcterms:W3CDTF">2018-07-25T12:25:09Z</dcterms:created>
  <dcterms:modified xsi:type="dcterms:W3CDTF">2018-09-13T06:45:52Z</dcterms:modified>
</cp:coreProperties>
</file>